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694"/>
  </p:normalViewPr>
  <p:slideViewPr>
    <p:cSldViewPr snapToGrid="0">
      <p:cViewPr varScale="1">
        <p:scale>
          <a:sx n="121" d="100"/>
          <a:sy n="121" d="100"/>
        </p:scale>
        <p:origin x="7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D43A44-9BC3-379B-B4C0-6F3051BD00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FAAC20F-55C9-71AF-9EE5-60AF30AB73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BEE1301-6076-AFE6-ABD7-FD9665872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4046CD0-9B47-5127-4A78-934C4FB17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7BA6F8F-C20C-FEF9-83D0-49FEBB322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40039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D0A46F9-19E6-CA59-8409-B99E4A0754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3619589A-D9F4-73B5-BA07-3E16DD020B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7944B48-E617-82E7-0DB8-DE214F9A9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822BD7A-F9C9-2317-32C0-101951702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C27E053-E3FB-FF0D-6591-90473B7A3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176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EE1DBAD-F2DA-A06B-5107-9401877568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50833FF8-9A3B-905F-499D-4737E1BFB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30529C5-0FCB-718E-482A-AA55F6C6E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D5AF9E7-039E-CE22-6F1B-ABE3413CD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4A07ED5-511D-696B-9738-D5724937B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99930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BFEBFD-D47B-FCF0-3EA6-0DA3786A2E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2C20042-DD12-25D7-CDD0-B5E86B7621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3ED6D99-6CF5-EFC5-A4B2-6A00FB1AA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8ED9193-9E8A-E7A5-1DBB-CB3F39EB5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268B4BE-8B36-513E-ABBA-CF465CDD2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019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FCAEB9-DB60-BCCD-5029-1FD8E0065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892AD69-E512-6A1D-2857-46176C0A5D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7739991-BC61-3002-CD4A-7BBD59E8E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845107D-0E69-B0A7-CA2C-E52F68AD5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116C2A0-ACD7-39D8-82F9-CFA7DEA41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7593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05BFF5-B7F0-58A1-5FEA-33C183EB89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1BC1D37-9B32-98F3-30C7-085123CD19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CA2ACEF-B186-68D5-3A18-2E82C022DC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CA0A536-9C4F-48A8-83BA-40A82316C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22BD14E-40C1-00E4-1F93-2C16ABFB4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3684BE9-4F76-C598-1247-294348032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1621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1CA064-AB00-B8AB-758C-B2DF51814C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A5B798A8-057B-CA63-8566-1D0EA1AED6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92CD7366-E817-778B-61D7-640D3D8C0F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146CF5FF-594F-ED95-1D58-651DCE2781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493DEB5A-FFA1-81DF-7A67-9085FBA949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15B83138-8ED2-0947-D66C-DCCBFB085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96E68960-852B-D77B-2252-4F688BA47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478D5E5B-C05E-77FF-C09F-637BFC365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68593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C49AE5-F1D9-686F-6737-889365114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107F6E74-E9A2-3696-7968-D62243605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364A1905-BFB8-38C7-1114-0CE5040F7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30802949-6824-E415-E466-3424A7947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6222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E892670-118F-B7B8-9543-124C0D43C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8F13A7AC-496F-13F6-F09F-FF0E0AADD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5B9294A6-282C-7E0D-AC98-A6E92BF01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47246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686ABC6-72CB-6F95-16AD-D3C6A5E1D1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3B2282-D02D-5DE8-3FB1-F6BA6746FB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F8F289F3-F124-7C62-5FFC-5378504B80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607152D-6607-C0C6-F038-8065809C1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6D33B3B6-DC74-B8CE-D21C-7C0A2A006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B10816B-C451-AF06-903A-4CCBF594F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66235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B5E882-4AE9-4775-6297-F10F5B944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69395B52-AB85-A8DD-BD39-642BF3C0C6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373D9F76-8182-E282-BE20-B39AE8932D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3E319FC-75D9-2195-0C42-FAE1E772C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BA3B589-7AC0-39B6-63A7-967AA1235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E38941C-BC2C-C783-CC67-B7B58CBC6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28981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CEB0F46D-A485-4C48-F90B-05AEA4751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CF5AD31-5395-E8FF-4EF9-DC3A036D56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523A38F-2B03-90C1-9A68-85F4B565B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E57042-94C7-48AA-806A-6FE1165195B8}" type="datetimeFigureOut">
              <a:rPr lang="pt-BR" smtClean="0"/>
              <a:t>17/04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21C04B6-7948-BF98-E02C-E92B634BB0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71F37FA-E5CB-5ED5-3700-AEE9854831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E5E1DC-5309-4D3E-B628-FF092FAAB35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61756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710C8B0A-1153-D0BB-655B-E32C8E699F1F}"/>
              </a:ext>
            </a:extLst>
          </p:cNvPr>
          <p:cNvSpPr txBox="1"/>
          <p:nvPr/>
        </p:nvSpPr>
        <p:spPr>
          <a:xfrm>
            <a:off x="620114" y="5001115"/>
            <a:ext cx="110673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b="1" dirty="0" err="1"/>
              <a:t>Supplemental</a:t>
            </a:r>
            <a:r>
              <a:rPr lang="pt-BR" b="1" dirty="0"/>
              <a:t> figure S1: </a:t>
            </a:r>
            <a:r>
              <a:rPr lang="pt-BR" dirty="0"/>
              <a:t>Whole </a:t>
            </a:r>
            <a:r>
              <a:rPr lang="pt-BR" dirty="0" err="1"/>
              <a:t>cell</a:t>
            </a:r>
            <a:r>
              <a:rPr lang="pt-BR" dirty="0"/>
              <a:t> </a:t>
            </a:r>
            <a:r>
              <a:rPr lang="pt-BR" dirty="0" err="1"/>
              <a:t>extract</a:t>
            </a:r>
            <a:r>
              <a:rPr lang="pt-BR" dirty="0"/>
              <a:t> </a:t>
            </a:r>
            <a:r>
              <a:rPr lang="pt-BR" dirty="0" err="1"/>
              <a:t>from</a:t>
            </a:r>
            <a:r>
              <a:rPr lang="pt-BR" dirty="0"/>
              <a:t> </a:t>
            </a:r>
            <a:r>
              <a:rPr lang="pt-BR" b="1" dirty="0"/>
              <a:t>XP4PA</a:t>
            </a:r>
            <a:r>
              <a:rPr lang="pt-BR" dirty="0"/>
              <a:t> (XP-C, </a:t>
            </a:r>
            <a:r>
              <a:rPr lang="pt-BR" dirty="0" err="1"/>
              <a:t>lanes</a:t>
            </a:r>
            <a:r>
              <a:rPr lang="pt-BR" dirty="0"/>
              <a:t> 1 </a:t>
            </a:r>
            <a:r>
              <a:rPr lang="pt-BR" dirty="0" err="1"/>
              <a:t>and</a:t>
            </a:r>
            <a:r>
              <a:rPr lang="pt-BR" dirty="0"/>
              <a:t> 2, 40 </a:t>
            </a:r>
            <a:r>
              <a:rPr lang="pt-BR" dirty="0" err="1"/>
              <a:t>or</a:t>
            </a:r>
            <a:r>
              <a:rPr lang="pt-BR" dirty="0"/>
              <a:t> 60 µ</a:t>
            </a:r>
            <a:r>
              <a:rPr lang="pt-BR" dirty="0" err="1"/>
              <a:t>g</a:t>
            </a:r>
            <a:r>
              <a:rPr lang="pt-BR" dirty="0"/>
              <a:t> </a:t>
            </a:r>
            <a:r>
              <a:rPr lang="pt-BR" dirty="0" err="1"/>
              <a:t>of</a:t>
            </a:r>
            <a:r>
              <a:rPr lang="pt-BR" dirty="0"/>
              <a:t> protein/</a:t>
            </a:r>
            <a:r>
              <a:rPr lang="pt-BR" dirty="0" err="1"/>
              <a:t>well</a:t>
            </a:r>
            <a:r>
              <a:rPr lang="pt-BR" dirty="0"/>
              <a:t>, </a:t>
            </a:r>
            <a:r>
              <a:rPr lang="pt-BR" dirty="0" err="1"/>
              <a:t>respectively</a:t>
            </a:r>
            <a:r>
              <a:rPr lang="pt-BR" dirty="0"/>
              <a:t>) </a:t>
            </a:r>
            <a:r>
              <a:rPr lang="pt-BR" dirty="0" err="1"/>
              <a:t>or</a:t>
            </a:r>
            <a:r>
              <a:rPr lang="pt-BR" dirty="0"/>
              <a:t> </a:t>
            </a:r>
            <a:r>
              <a:rPr lang="pt-BR" b="1" dirty="0"/>
              <a:t>XP4PA-CR</a:t>
            </a:r>
            <a:r>
              <a:rPr lang="pt-BR" dirty="0"/>
              <a:t> (XP-C </a:t>
            </a:r>
            <a:r>
              <a:rPr lang="pt-BR" dirty="0" err="1"/>
              <a:t>corrected</a:t>
            </a:r>
            <a:r>
              <a:rPr lang="pt-BR" dirty="0"/>
              <a:t>, </a:t>
            </a:r>
            <a:r>
              <a:rPr lang="pt-BR" dirty="0" err="1"/>
              <a:t>lanes</a:t>
            </a:r>
            <a:r>
              <a:rPr lang="pt-BR" dirty="0"/>
              <a:t> 3-5, 20, 40 </a:t>
            </a:r>
            <a:r>
              <a:rPr lang="pt-BR" dirty="0" err="1"/>
              <a:t>or</a:t>
            </a:r>
            <a:r>
              <a:rPr lang="pt-BR" dirty="0"/>
              <a:t> 60 µ</a:t>
            </a:r>
            <a:r>
              <a:rPr lang="pt-BR" dirty="0" err="1"/>
              <a:t>g</a:t>
            </a:r>
            <a:r>
              <a:rPr lang="pt-BR" dirty="0"/>
              <a:t> protein/</a:t>
            </a:r>
            <a:r>
              <a:rPr lang="pt-BR" dirty="0" err="1"/>
              <a:t>well</a:t>
            </a:r>
            <a:r>
              <a:rPr lang="pt-BR" dirty="0"/>
              <a:t>, </a:t>
            </a:r>
            <a:r>
              <a:rPr lang="pt-BR" dirty="0" err="1"/>
              <a:t>respectively</a:t>
            </a:r>
            <a:r>
              <a:rPr lang="pt-BR" dirty="0"/>
              <a:t>) </a:t>
            </a:r>
            <a:r>
              <a:rPr lang="pt-BR" dirty="0" err="1"/>
              <a:t>were</a:t>
            </a:r>
            <a:r>
              <a:rPr lang="pt-BR" dirty="0"/>
              <a:t> </a:t>
            </a:r>
            <a:r>
              <a:rPr lang="pt-BR" dirty="0" err="1"/>
              <a:t>resolved</a:t>
            </a:r>
            <a:r>
              <a:rPr lang="pt-BR" dirty="0"/>
              <a:t> </a:t>
            </a:r>
            <a:r>
              <a:rPr lang="pt-BR" dirty="0" err="1"/>
              <a:t>by</a:t>
            </a:r>
            <a:r>
              <a:rPr lang="pt-BR" dirty="0"/>
              <a:t> SDS-PAGE </a:t>
            </a:r>
            <a:r>
              <a:rPr lang="pt-BR" dirty="0" err="1"/>
              <a:t>and</a:t>
            </a:r>
            <a:r>
              <a:rPr lang="pt-BR" dirty="0"/>
              <a:t> </a:t>
            </a:r>
            <a:r>
              <a:rPr lang="pt-BR" dirty="0" err="1"/>
              <a:t>probed</a:t>
            </a:r>
            <a:r>
              <a:rPr lang="pt-BR" dirty="0"/>
              <a:t> </a:t>
            </a:r>
            <a:r>
              <a:rPr lang="pt-BR" dirty="0" err="1"/>
              <a:t>with</a:t>
            </a:r>
            <a:r>
              <a:rPr lang="pt-BR" dirty="0"/>
              <a:t> </a:t>
            </a:r>
            <a:r>
              <a:rPr lang="pt-BR" dirty="0" err="1"/>
              <a:t>anti</a:t>
            </a:r>
            <a:r>
              <a:rPr lang="pt-BR" dirty="0"/>
              <a:t>-</a:t>
            </a:r>
            <a:r>
              <a:rPr lang="en-US" dirty="0"/>
              <a:t>XPC(Abcam)  and anti-β-actin (loading control; Sigma–Aldrich). Images were obtained by chemiluminescence. Representative image of at least 3 independent experiments</a:t>
            </a:r>
            <a:endParaRPr lang="pt-BR" dirty="0"/>
          </a:p>
        </p:txBody>
      </p:sp>
      <p:grpSp>
        <p:nvGrpSpPr>
          <p:cNvPr id="10" name="Agrupar 9">
            <a:extLst>
              <a:ext uri="{FF2B5EF4-FFF2-40B4-BE49-F238E27FC236}">
                <a16:creationId xmlns:a16="http://schemas.microsoft.com/office/drawing/2014/main" id="{274DC187-55E4-8F52-51B3-F9238CF790A2}"/>
              </a:ext>
            </a:extLst>
          </p:cNvPr>
          <p:cNvGrpSpPr/>
          <p:nvPr/>
        </p:nvGrpSpPr>
        <p:grpSpPr>
          <a:xfrm>
            <a:off x="2550941" y="1741702"/>
            <a:ext cx="7205739" cy="3029010"/>
            <a:chOff x="1923393" y="1857316"/>
            <a:chExt cx="7205739" cy="3029010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90DE5175-73DB-5A3F-896F-B8EF23DDB7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8281" t="39722" r="42422" b="33472"/>
            <a:stretch/>
          </p:blipFill>
          <p:spPr>
            <a:xfrm>
              <a:off x="2781300" y="2276476"/>
              <a:ext cx="5070952" cy="2609850"/>
            </a:xfrm>
            <a:prstGeom prst="rect">
              <a:avLst/>
            </a:prstGeom>
          </p:spPr>
        </p:pic>
        <p:sp>
          <p:nvSpPr>
            <p:cNvPr id="7" name="CaixaDeTexto 6">
              <a:extLst>
                <a:ext uri="{FF2B5EF4-FFF2-40B4-BE49-F238E27FC236}">
                  <a16:creationId xmlns:a16="http://schemas.microsoft.com/office/drawing/2014/main" id="{787BB7E5-20A2-15DA-5E18-E79A00B4A7AA}"/>
                </a:ext>
              </a:extLst>
            </p:cNvPr>
            <p:cNvSpPr txBox="1"/>
            <p:nvPr/>
          </p:nvSpPr>
          <p:spPr>
            <a:xfrm>
              <a:off x="1923393" y="1857316"/>
              <a:ext cx="59288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2000" dirty="0"/>
                <a:t>Lane          1                2              3                4                5</a:t>
              </a:r>
            </a:p>
          </p:txBody>
        </p:sp>
        <p:sp>
          <p:nvSpPr>
            <p:cNvPr id="14" name="CaixaDeTexto 13">
              <a:extLst>
                <a:ext uri="{FF2B5EF4-FFF2-40B4-BE49-F238E27FC236}">
                  <a16:creationId xmlns:a16="http://schemas.microsoft.com/office/drawing/2014/main" id="{B2E8378E-496F-782D-7172-D6A7FF45101E}"/>
                </a:ext>
              </a:extLst>
            </p:cNvPr>
            <p:cNvSpPr txBox="1"/>
            <p:nvPr/>
          </p:nvSpPr>
          <p:spPr>
            <a:xfrm>
              <a:off x="8150822" y="2419576"/>
              <a:ext cx="7521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2000" dirty="0"/>
                <a:t>XPC</a:t>
              </a:r>
            </a:p>
          </p:txBody>
        </p:sp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7177F558-2B4E-DF56-D630-564CAB09FBF0}"/>
                </a:ext>
              </a:extLst>
            </p:cNvPr>
            <p:cNvSpPr txBox="1"/>
            <p:nvPr/>
          </p:nvSpPr>
          <p:spPr>
            <a:xfrm>
              <a:off x="8150822" y="3508022"/>
              <a:ext cx="97831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2000" dirty="0"/>
                <a:t>β</a:t>
              </a:r>
              <a:r>
                <a:rPr lang="pt-BR" sz="2000" dirty="0"/>
                <a:t>-</a:t>
              </a:r>
              <a:r>
                <a:rPr lang="pt-BR" sz="2000" dirty="0" err="1"/>
                <a:t>actin</a:t>
              </a:r>
              <a:endParaRPr lang="pt-BR" sz="2000" dirty="0"/>
            </a:p>
          </p:txBody>
        </p:sp>
        <p:cxnSp>
          <p:nvCxnSpPr>
            <p:cNvPr id="5" name="Conector de Seta Reta 4">
              <a:extLst>
                <a:ext uri="{FF2B5EF4-FFF2-40B4-BE49-F238E27FC236}">
                  <a16:creationId xmlns:a16="http://schemas.microsoft.com/office/drawing/2014/main" id="{D3F7EE11-A650-AE93-1653-928F46E49B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12382" y="2619631"/>
              <a:ext cx="52803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Conector de Seta Reta 5">
              <a:extLst>
                <a:ext uri="{FF2B5EF4-FFF2-40B4-BE49-F238E27FC236}">
                  <a16:creationId xmlns:a16="http://schemas.microsoft.com/office/drawing/2014/main" id="{4E77DBB4-DD29-A16D-D920-B20E1CA867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12382" y="3715887"/>
              <a:ext cx="52803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" name="CaixaDeTexto 7">
            <a:extLst>
              <a:ext uri="{FF2B5EF4-FFF2-40B4-BE49-F238E27FC236}">
                <a16:creationId xmlns:a16="http://schemas.microsoft.com/office/drawing/2014/main" id="{585F90EC-93AE-3B36-C005-9670A113CDAC}"/>
              </a:ext>
            </a:extLst>
          </p:cNvPr>
          <p:cNvSpPr txBox="1"/>
          <p:nvPr/>
        </p:nvSpPr>
        <p:spPr>
          <a:xfrm>
            <a:off x="4832647" y="311198"/>
            <a:ext cx="2642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material </a:t>
            </a:r>
          </a:p>
        </p:txBody>
      </p:sp>
    </p:spTree>
    <p:extLst>
      <p:ext uri="{BB962C8B-B14F-4D97-AF65-F5344CB8AC3E}">
        <p14:creationId xmlns:p14="http://schemas.microsoft.com/office/powerpoint/2010/main" val="15591159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96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iana 𓅈</dc:creator>
  <cp:lastModifiedBy>Nadja Souza Pinto</cp:lastModifiedBy>
  <cp:revision>5</cp:revision>
  <dcterms:created xsi:type="dcterms:W3CDTF">2025-04-16T14:03:08Z</dcterms:created>
  <dcterms:modified xsi:type="dcterms:W3CDTF">2025-04-17T13:34:23Z</dcterms:modified>
</cp:coreProperties>
</file>